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0" d="100"/>
          <a:sy n="70" d="100"/>
        </p:scale>
        <p:origin x="714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57107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84411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9180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3231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83099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7804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8047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29028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71533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2891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16220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AECAFB-FBF9-408A-872D-6091B162642E}" type="datetimeFigureOut">
              <a:rPr lang="zh-CN" altLang="en-US" smtClean="0"/>
              <a:t>2024/4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42A55-2215-4BCC-829F-13719300EB8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341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8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tif"/><Relationship Id="rId2" Type="http://schemas.openxmlformats.org/officeDocument/2006/relationships/image" Target="../media/image29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1.tif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4.tif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tiff"/><Relationship Id="rId2" Type="http://schemas.openxmlformats.org/officeDocument/2006/relationships/image" Target="../media/image35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7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tiff"/><Relationship Id="rId2" Type="http://schemas.openxmlformats.org/officeDocument/2006/relationships/image" Target="../media/image32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3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tiff"/><Relationship Id="rId2" Type="http://schemas.openxmlformats.org/officeDocument/2006/relationships/image" Target="../media/image39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1.tif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tiff"/><Relationship Id="rId2" Type="http://schemas.openxmlformats.org/officeDocument/2006/relationships/image" Target="../media/image42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4.tif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7.ti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tiff"/><Relationship Id="rId2" Type="http://schemas.openxmlformats.org/officeDocument/2006/relationships/image" Target="../media/image48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0.tiff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2.tiff"/><Relationship Id="rId2" Type="http://schemas.openxmlformats.org/officeDocument/2006/relationships/image" Target="../media/image5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.tiff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tiff"/><Relationship Id="rId2" Type="http://schemas.openxmlformats.org/officeDocument/2006/relationships/image" Target="../media/image54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6.tiff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8.tiff"/><Relationship Id="rId2" Type="http://schemas.openxmlformats.org/officeDocument/2006/relationships/image" Target="../media/image57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9.tiff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tiff"/><Relationship Id="rId2" Type="http://schemas.openxmlformats.org/officeDocument/2006/relationships/image" Target="../media/image6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2.tif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tiff"/><Relationship Id="rId2" Type="http://schemas.openxmlformats.org/officeDocument/2006/relationships/image" Target="../media/image6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65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f"/><Relationship Id="rId2" Type="http://schemas.openxmlformats.org/officeDocument/2006/relationships/image" Target="../media/image1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5.jp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8.jp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jp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tiff"/><Relationship Id="rId2" Type="http://schemas.openxmlformats.org/officeDocument/2006/relationships/image" Target="../media/image20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2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5" y="503996"/>
            <a:ext cx="2734102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1D-N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0076" y="1945396"/>
            <a:ext cx="3278539" cy="2680024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8322" y="1923333"/>
            <a:ext cx="3328416" cy="272415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96446" y="1923333"/>
            <a:ext cx="3421975" cy="279727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4338415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C-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33980" y="2021985"/>
            <a:ext cx="3544921" cy="2897776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226" y="2063862"/>
            <a:ext cx="3442466" cy="281402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768" y="2056411"/>
            <a:ext cx="3456432" cy="282892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194277985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C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433" y="2177369"/>
            <a:ext cx="3476381" cy="285458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75874" y="2177369"/>
            <a:ext cx="3520440" cy="2881313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2374" y="2185765"/>
            <a:ext cx="3466156" cy="2846193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457596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A-LC3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4343" y="1590027"/>
            <a:ext cx="2952172" cy="4059237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3119" y="1548605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2971" y="1548605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1967486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A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6943" y="1435693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709" y="1435693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5667" y="1435693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778870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B-LC3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85389" y="1637977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98921" y="1637977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0310" y="1637977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2696669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B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77179" y="1435903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2878" y="1435903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10116" y="1407286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2387606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B-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3165" y="1960955"/>
            <a:ext cx="3425258" cy="281261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2274" y="2005185"/>
            <a:ext cx="3261663" cy="2678276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4343" y="2005185"/>
            <a:ext cx="3328416" cy="272415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595912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4B-STING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1514" y="2017405"/>
            <a:ext cx="3701323" cy="3039298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611" y="2017405"/>
            <a:ext cx="3742222" cy="3072881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3778" y="2017405"/>
            <a:ext cx="3712464" cy="303847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117290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A-ATG5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8705" y="1476180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25881" y="1476180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375" y="1504586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40816340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A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39524" y="1580226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73158" y="1551399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858" y="1522993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978843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3916907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1D-β-tubulin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865" y="2182667"/>
            <a:ext cx="3299030" cy="2696774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0453" y="2185167"/>
            <a:ext cx="3328416" cy="272415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59917" y="2121093"/>
            <a:ext cx="3442466" cy="281402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17918993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B-LC3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30342" y="1515567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06855" y="1486740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0778" y="1486740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6155644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B-LC3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9648" y="1561164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37286" y="1503931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2808" y="1503931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259101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B-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77832" y="2143016"/>
            <a:ext cx="3599077" cy="29553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193" y="2071002"/>
            <a:ext cx="3660425" cy="3005714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6501" y="2143016"/>
            <a:ext cx="3584448" cy="293370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34543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5B-STING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70782" y="2074901"/>
            <a:ext cx="3650200" cy="2997318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340" y="2053499"/>
            <a:ext cx="3752447" cy="3081277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08123" y="2074901"/>
            <a:ext cx="3712464" cy="303847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6533505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2B-Cleaved ATF6</a:t>
            </a:r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8025" y="1552821"/>
            <a:ext cx="2950312" cy="4057193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58619" y="1569738"/>
            <a:ext cx="2926080" cy="4023360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10913" y="1569738"/>
            <a:ext cx="2981992" cy="41002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78248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2B</a:t>
            </a:r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0333" y="1488717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9986" y="1487816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2721" y="1516432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4882742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A-LC3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6114" y="1721393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1751" y="1721393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48706" y="1778626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9646753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A-STING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38572" y="1880995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44450" y="1880995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5573" y="1881415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5456899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A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9512" y="1665273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01904" y="1680241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5614" y="1680241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2291004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B-STING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1325" y="1733511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09277" y="1733511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21252" y="1733931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956412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11414" y="503996"/>
            <a:ext cx="4961589" cy="778894"/>
          </a:xfrm>
        </p:spPr>
        <p:txBody>
          <a:bodyPr>
            <a:normAutofit/>
          </a:bodyPr>
          <a:lstStyle/>
          <a:p>
            <a:pPr algn="l"/>
            <a:r>
              <a:rPr lang="en-US" altLang="zh-CN" sz="3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3B-β-tubulin</a:t>
            </a:r>
            <a:endParaRPr lang="zh-CN" altLang="en-US" sz="3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l"/>
            <a:endParaRPr lang="zh-CN" alt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8741" y="1516468"/>
            <a:ext cx="3023616" cy="4157472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05442" y="1516048"/>
            <a:ext cx="2982298" cy="410065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16456" y="1516468"/>
            <a:ext cx="2981992" cy="4100239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</p:spTree>
    <p:extLst>
      <p:ext uri="{BB962C8B-B14F-4D97-AF65-F5344CB8AC3E}">
        <p14:creationId xmlns:p14="http://schemas.microsoft.com/office/powerpoint/2010/main" val="309062231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</TotalTime>
  <Words>70</Words>
  <Application>Microsoft Office PowerPoint</Application>
  <PresentationFormat>宽屏</PresentationFormat>
  <Paragraphs>23</Paragraphs>
  <Slides>2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3</vt:i4>
      </vt:variant>
    </vt:vector>
  </HeadingPairs>
  <TitlesOfParts>
    <vt:vector size="29" baseType="lpstr">
      <vt:lpstr>宋体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34</cp:revision>
  <dcterms:created xsi:type="dcterms:W3CDTF">2024-04-23T09:43:42Z</dcterms:created>
  <dcterms:modified xsi:type="dcterms:W3CDTF">2024-04-23T10:42:01Z</dcterms:modified>
</cp:coreProperties>
</file>